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9" autoAdjust="0"/>
    <p:restoredTop sz="94660"/>
  </p:normalViewPr>
  <p:slideViewPr>
    <p:cSldViewPr snapToGrid="0">
      <p:cViewPr varScale="1">
        <p:scale>
          <a:sx n="152" d="100"/>
          <a:sy n="152" d="100"/>
        </p:scale>
        <p:origin x="576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0E209-A1A1-5284-E2CC-6D57C15CAB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E3D8092-8BEE-7D77-83C0-5A7A43D9C3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D952C-C4BE-A84C-D6CB-A9A91682A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BED2C6-D0BF-019D-92FB-533F3DE6E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A64433-6126-8314-4737-4FC5273E7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983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99AE60-F715-68E6-E01A-31588C4851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BCB15D-B557-F127-E289-3CB17F69D1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038EBD-2F50-B656-0E62-E8F5DE1E7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1B3A3C-2DFA-A13A-0ACC-3A2FC305B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BDC70F-D7B6-FB1F-07A6-7B5E121C8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045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FF74C5-71D7-39CD-F246-905CAFA24B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8E252B-612F-D794-8B6D-79A58CC57D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5DF123-9049-4AAA-7C5B-70894FBE1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8DB898-2C6A-88FF-918D-2E73D8377E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F0FC00-1AED-1B92-5E71-FF9CB2476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855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3113A4-B6EC-89E4-DA93-72D5C9ACF2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7151CF-E455-A6D5-77C8-9056FCF477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70E3B1-102B-0D33-52E4-4891F3614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5EBEC9-A489-E851-DA3E-C561D61E0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010D34-702C-88EF-5994-FE4849E14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834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6EB51-DFD1-DAA6-491F-9C7C4B87AD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5735F4-674D-3F45-2A36-8BD4860B58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536D0C-7C3A-DD4D-0DD3-BCD737050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6C84A7-89AA-1EAD-32A6-113E6852B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9BB766-AFE6-A4B5-9B08-2A83E6D3A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323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AB70C2-297C-DCFC-39C3-C06605E213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35D15A-AF9C-5AD0-FA3D-A35463BA13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A60470-0B40-FF56-82D4-407C11741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369F24-52CD-19D7-A5A0-DF2677E62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92450C-68BB-E3C7-C594-46B99CB6A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69CDF7-8DC7-0425-58F8-AECCE3D8E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211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60144D-CA49-D215-C5B2-71F061D4E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E9925C-1739-968D-EC29-26D5AF60C4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6B06E0-F970-EF43-B881-54FD0FED8D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4B4F53-3C64-1A37-28AC-69B247DEC2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DD6D6E9-EA83-CC64-7FC5-68315EF0E1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97FBEE-5F15-AD05-F08A-F88178966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92412AB-0F34-A064-AA03-809E87D8A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389333-9E6D-DB9B-E21F-6CA3B1D3C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22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A204AE-C898-5568-4FA8-28C615E4AB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0BF32A-D8AE-34F4-B112-E98513BDB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207C5A-CE2F-96ED-5627-5DD7EFC0A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6CFBAB-F7D3-AF9A-CEC1-D90B495D2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36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BDF5322-9212-DDA5-88B7-50E81FA71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D90BF4-0B31-3ECB-CF8E-2B126A4F7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F710EC-B94E-0414-47C3-99621780C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885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0D732A-FBD5-E723-BF11-4BCE92DE50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4D27D1-268E-3166-5CFC-C0A27D78E0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685E46-DBFE-0838-7C39-C236E40A21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AC0882-E28E-192A-ED9E-10326CEB4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C6A3E7-1AA2-8782-AD00-0EC963123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2505FA-7416-2B83-D34C-6A57EC0B6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924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69597-204E-97A9-8DD5-C37B6F25A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FDD1EE-2A77-4E2A-7B07-0B5509D355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6C25AB-A148-E941-75ED-BECFD4DDE5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B6EBB3-5DAE-4AE6-3EBB-A45AC5C5D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EA9515-46F0-9F7E-7C17-B0AF5BE14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6C300A-695C-9785-FEE0-F53E01EE6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5574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2B53AA-579F-A69D-A22C-6CA91A1F5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653DC2-FE8E-A4D6-A8B2-F34D75334E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C1BC5C-C341-16B0-FDE6-923B7384BB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B1028C-B96D-40E2-A0B8-550DEA4021EF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C8641E-4748-0132-CD05-F4F9484D7A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F2C514-E486-C5F0-6C91-B17C52615E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B43DE9-D123-4A2E-A6B3-911A18CA5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749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8.tif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image" Target="../media/image7.tif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6.tiff"/><Relationship Id="rId5" Type="http://schemas.openxmlformats.org/officeDocument/2006/relationships/image" Target="../media/image2.emf"/><Relationship Id="rId10" Type="http://schemas.openxmlformats.org/officeDocument/2006/relationships/image" Target="../media/image5.tif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88302EE-B6E9-863C-3AC5-F18C787337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2810994"/>
              </p:ext>
            </p:extLst>
          </p:nvPr>
        </p:nvGraphicFramePr>
        <p:xfrm>
          <a:off x="2597086" y="462968"/>
          <a:ext cx="2073420" cy="23931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396800" imgH="3921633" progId="Prism10.Document">
                  <p:embed/>
                </p:oleObj>
              </mc:Choice>
              <mc:Fallback>
                <p:oleObj name="Prism 10" r:id="rId2" imgW="3396800" imgH="392163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97086" y="462968"/>
                        <a:ext cx="2073420" cy="23931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18382EE-E3C1-769D-1D13-17F5D5DBE6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9571794"/>
              </p:ext>
            </p:extLst>
          </p:nvPr>
        </p:nvGraphicFramePr>
        <p:xfrm>
          <a:off x="2567985" y="3025223"/>
          <a:ext cx="2291293" cy="2309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437856" imgH="3466174" progId="Prism10.Document">
                  <p:embed/>
                </p:oleObj>
              </mc:Choice>
              <mc:Fallback>
                <p:oleObj name="Prism 10" r:id="rId4" imgW="3437856" imgH="346617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567985" y="3025223"/>
                        <a:ext cx="2291293" cy="23092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7616ED6-9979-9605-C357-E39B89DC88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1709001"/>
              </p:ext>
            </p:extLst>
          </p:nvPr>
        </p:nvGraphicFramePr>
        <p:xfrm>
          <a:off x="7157578" y="427201"/>
          <a:ext cx="2182097" cy="2464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480712" imgH="3932435" progId="Prism10.Document">
                  <p:embed/>
                </p:oleObj>
              </mc:Choice>
              <mc:Fallback>
                <p:oleObj name="Prism 10" r:id="rId6" imgW="3480712" imgH="39324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157578" y="427201"/>
                        <a:ext cx="2182097" cy="24646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A44FB1FE-2C4F-CACE-68DA-EA4D87F18F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3702891"/>
              </p:ext>
            </p:extLst>
          </p:nvPr>
        </p:nvGraphicFramePr>
        <p:xfrm>
          <a:off x="7386251" y="3031502"/>
          <a:ext cx="2002867" cy="2309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404363" imgH="3924874" progId="Prism10.Document">
                  <p:embed/>
                </p:oleObj>
              </mc:Choice>
              <mc:Fallback>
                <p:oleObj name="Prism 10" r:id="rId8" imgW="3404363" imgH="392487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386251" y="3031502"/>
                        <a:ext cx="2002867" cy="23092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7D72E8F4-C7BD-0E8D-1063-D2C05BF3D82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82331" y="3114307"/>
            <a:ext cx="1803400" cy="1778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9AE1961-24BD-6729-CA07-C2759156D8DA}"/>
              </a:ext>
            </a:extLst>
          </p:cNvPr>
          <p:cNvSpPr txBox="1"/>
          <p:nvPr/>
        </p:nvSpPr>
        <p:spPr>
          <a:xfrm>
            <a:off x="6679638" y="4465056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197A16A-40CA-BD8A-3954-AC76FAD056F3}"/>
              </a:ext>
            </a:extLst>
          </p:cNvPr>
          <p:cNvSpPr txBox="1"/>
          <p:nvPr/>
        </p:nvSpPr>
        <p:spPr>
          <a:xfrm>
            <a:off x="6724119" y="3976415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DD0F933-BF1A-9C19-F7AC-068C2D686E58}"/>
              </a:ext>
            </a:extLst>
          </p:cNvPr>
          <p:cNvSpPr txBox="1"/>
          <p:nvPr/>
        </p:nvSpPr>
        <p:spPr>
          <a:xfrm>
            <a:off x="6679638" y="341435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A845B6F-1F62-414C-DB20-14C2D11DEA72}"/>
              </a:ext>
            </a:extLst>
          </p:cNvPr>
          <p:cNvCxnSpPr/>
          <p:nvPr/>
        </p:nvCxnSpPr>
        <p:spPr>
          <a:xfrm>
            <a:off x="5169716" y="5022167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D4868C3B-E446-224B-AA00-143054F245C7}"/>
              </a:ext>
            </a:extLst>
          </p:cNvPr>
          <p:cNvSpPr txBox="1"/>
          <p:nvPr/>
        </p:nvSpPr>
        <p:spPr>
          <a:xfrm>
            <a:off x="5916287" y="4880945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69 (RAJI)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7235BDA2-1147-BD47-DDA8-F227169D7CA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03180" y="663802"/>
            <a:ext cx="1803400" cy="1778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72128845-3174-2A2A-A3EC-67B9CA0AD6DF}"/>
              </a:ext>
            </a:extLst>
          </p:cNvPr>
          <p:cNvSpPr txBox="1"/>
          <p:nvPr/>
        </p:nvSpPr>
        <p:spPr>
          <a:xfrm>
            <a:off x="6434562" y="1926574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EA93FB9-0AB8-6C8E-FF27-F74B76B85A11}"/>
              </a:ext>
            </a:extLst>
          </p:cNvPr>
          <p:cNvSpPr txBox="1"/>
          <p:nvPr/>
        </p:nvSpPr>
        <p:spPr>
          <a:xfrm>
            <a:off x="6434561" y="142969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DCBCD15-98B8-78F0-0094-A35DC528EE9D}"/>
              </a:ext>
            </a:extLst>
          </p:cNvPr>
          <p:cNvSpPr txBox="1"/>
          <p:nvPr/>
        </p:nvSpPr>
        <p:spPr>
          <a:xfrm>
            <a:off x="6390080" y="867627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00C3ACAF-08EF-2F53-FAAE-6484B17D48A2}"/>
              </a:ext>
            </a:extLst>
          </p:cNvPr>
          <p:cNvCxnSpPr/>
          <p:nvPr/>
        </p:nvCxnSpPr>
        <p:spPr>
          <a:xfrm>
            <a:off x="4882331" y="2588340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3D19968B-DF80-8EBB-C47E-71A0E9135A29}"/>
              </a:ext>
            </a:extLst>
          </p:cNvPr>
          <p:cNvSpPr txBox="1"/>
          <p:nvPr/>
        </p:nvSpPr>
        <p:spPr>
          <a:xfrm>
            <a:off x="5628902" y="2447118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47 (RAJI)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406E35CD-FF86-ED47-003A-5E99C3B779E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3922" y="3044402"/>
            <a:ext cx="1803400" cy="17780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ED6BF508-6725-C3E0-71D0-BA8489B9F744}"/>
              </a:ext>
            </a:extLst>
          </p:cNvPr>
          <p:cNvSpPr txBox="1"/>
          <p:nvPr/>
        </p:nvSpPr>
        <p:spPr>
          <a:xfrm>
            <a:off x="1149489" y="4419194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1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CC23F47-130D-9A23-7FAA-FE1BEA040709}"/>
              </a:ext>
            </a:extLst>
          </p:cNvPr>
          <p:cNvSpPr txBox="1"/>
          <p:nvPr/>
        </p:nvSpPr>
        <p:spPr>
          <a:xfrm>
            <a:off x="280340" y="3889721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282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14C750C-E3EF-D4A0-B8E8-AC16FE2F3F58}"/>
              </a:ext>
            </a:extLst>
          </p:cNvPr>
          <p:cNvSpPr txBox="1"/>
          <p:nvPr/>
        </p:nvSpPr>
        <p:spPr>
          <a:xfrm>
            <a:off x="280340" y="3343951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9684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D40DCDE6-C3A7-21C9-938B-417B092798E3}"/>
              </a:ext>
            </a:extLst>
          </p:cNvPr>
          <p:cNvCxnSpPr/>
          <p:nvPr/>
        </p:nvCxnSpPr>
        <p:spPr>
          <a:xfrm>
            <a:off x="402918" y="4968064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239E2A34-C11E-721E-B0D2-D7B4D19DE9D9}"/>
              </a:ext>
            </a:extLst>
          </p:cNvPr>
          <p:cNvSpPr txBox="1"/>
          <p:nvPr/>
        </p:nvSpPr>
        <p:spPr>
          <a:xfrm>
            <a:off x="1149489" y="4826842"/>
            <a:ext cx="9525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69 (BJAB)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888706BA-6D25-E967-21B5-3CF3E37DCB7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71213" y="652028"/>
            <a:ext cx="1803400" cy="1778000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EEAB7C2-8AD3-9E23-9669-F302D84C72F9}"/>
              </a:ext>
            </a:extLst>
          </p:cNvPr>
          <p:cNvSpPr txBox="1"/>
          <p:nvPr/>
        </p:nvSpPr>
        <p:spPr>
          <a:xfrm>
            <a:off x="1264504" y="1926573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2315C1E-DE99-7EE9-1C8F-4EFEBB13FE33}"/>
              </a:ext>
            </a:extLst>
          </p:cNvPr>
          <p:cNvSpPr txBox="1"/>
          <p:nvPr/>
        </p:nvSpPr>
        <p:spPr>
          <a:xfrm>
            <a:off x="405628" y="1251906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616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25CC0CE-DB09-24B4-B335-3DD7858C6BCD}"/>
              </a:ext>
            </a:extLst>
          </p:cNvPr>
          <p:cNvSpPr txBox="1"/>
          <p:nvPr/>
        </p:nvSpPr>
        <p:spPr>
          <a:xfrm>
            <a:off x="405628" y="706136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7170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FB59ACD6-54F6-E624-F09B-61338D0D8BF6}"/>
              </a:ext>
            </a:extLst>
          </p:cNvPr>
          <p:cNvCxnSpPr/>
          <p:nvPr/>
        </p:nvCxnSpPr>
        <p:spPr>
          <a:xfrm>
            <a:off x="453763" y="2566981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48174E8E-76EE-855B-1624-B55AAC9A0E73}"/>
              </a:ext>
            </a:extLst>
          </p:cNvPr>
          <p:cNvSpPr txBox="1"/>
          <p:nvPr/>
        </p:nvSpPr>
        <p:spPr>
          <a:xfrm>
            <a:off x="1200334" y="2425759"/>
            <a:ext cx="9525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47 (BJAB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8228EE8-844B-C6FD-3764-9A4F7788190B}"/>
              </a:ext>
            </a:extLst>
          </p:cNvPr>
          <p:cNvSpPr txBox="1"/>
          <p:nvPr/>
        </p:nvSpPr>
        <p:spPr>
          <a:xfrm>
            <a:off x="2085962" y="4279787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D5C9DFF-510E-054F-2A4A-B9A68B8C8327}"/>
              </a:ext>
            </a:extLst>
          </p:cNvPr>
          <p:cNvSpPr txBox="1"/>
          <p:nvPr/>
        </p:nvSpPr>
        <p:spPr>
          <a:xfrm>
            <a:off x="2085961" y="3782905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513B8FE-CC84-CE51-876E-279AC10AA23A}"/>
              </a:ext>
            </a:extLst>
          </p:cNvPr>
          <p:cNvSpPr txBox="1"/>
          <p:nvPr/>
        </p:nvSpPr>
        <p:spPr>
          <a:xfrm>
            <a:off x="2041480" y="322084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FFB8AC0-3F79-F130-4107-08AC19606B22}"/>
              </a:ext>
            </a:extLst>
          </p:cNvPr>
          <p:cNvSpPr txBox="1"/>
          <p:nvPr/>
        </p:nvSpPr>
        <p:spPr>
          <a:xfrm>
            <a:off x="2009209" y="1913450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2452147-78BC-A5B2-517F-B789FBAC7310}"/>
              </a:ext>
            </a:extLst>
          </p:cNvPr>
          <p:cNvSpPr txBox="1"/>
          <p:nvPr/>
        </p:nvSpPr>
        <p:spPr>
          <a:xfrm>
            <a:off x="2018323" y="149812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3A585CA-C32E-5D10-63CE-7C9A2D8C9619}"/>
              </a:ext>
            </a:extLst>
          </p:cNvPr>
          <p:cNvSpPr txBox="1"/>
          <p:nvPr/>
        </p:nvSpPr>
        <p:spPr>
          <a:xfrm>
            <a:off x="1972654" y="920459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F81EBB8-6573-512E-32BF-48402D028C8C}"/>
              </a:ext>
            </a:extLst>
          </p:cNvPr>
          <p:cNvSpPr txBox="1"/>
          <p:nvPr/>
        </p:nvSpPr>
        <p:spPr>
          <a:xfrm>
            <a:off x="5567633" y="1790340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398E34B-7124-9E37-2AC8-5BF9725EEDFF}"/>
              </a:ext>
            </a:extLst>
          </p:cNvPr>
          <p:cNvSpPr txBox="1"/>
          <p:nvPr/>
        </p:nvSpPr>
        <p:spPr>
          <a:xfrm>
            <a:off x="4698484" y="1260867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1353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9AD5996-8518-C468-1788-E5F17662EF44}"/>
              </a:ext>
            </a:extLst>
          </p:cNvPr>
          <p:cNvSpPr txBox="1"/>
          <p:nvPr/>
        </p:nvSpPr>
        <p:spPr>
          <a:xfrm>
            <a:off x="4698484" y="715097"/>
            <a:ext cx="9044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214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0C64D6A-1611-4D46-F1FC-CC86FB3B9CE5}"/>
              </a:ext>
            </a:extLst>
          </p:cNvPr>
          <p:cNvSpPr txBox="1"/>
          <p:nvPr/>
        </p:nvSpPr>
        <p:spPr>
          <a:xfrm>
            <a:off x="5979118" y="4337180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20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1C44B9C-5715-FF70-257B-DBC6EAE1DD32}"/>
              </a:ext>
            </a:extLst>
          </p:cNvPr>
          <p:cNvSpPr txBox="1"/>
          <p:nvPr/>
        </p:nvSpPr>
        <p:spPr>
          <a:xfrm>
            <a:off x="5109969" y="3807707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6397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EFBE540-83D9-8594-708F-AFF31602149D}"/>
              </a:ext>
            </a:extLst>
          </p:cNvPr>
          <p:cNvSpPr txBox="1"/>
          <p:nvPr/>
        </p:nvSpPr>
        <p:spPr>
          <a:xfrm>
            <a:off x="5109969" y="3261937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7070</a:t>
            </a:r>
          </a:p>
        </p:txBody>
      </p:sp>
    </p:spTree>
    <p:extLst>
      <p:ext uri="{BB962C8B-B14F-4D97-AF65-F5344CB8AC3E}">
        <p14:creationId xmlns:p14="http://schemas.microsoft.com/office/powerpoint/2010/main" val="888076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64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GraphPad Prism Project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ur, Sukhbir (NIH/NCI) [E]</dc:creator>
  <cp:lastModifiedBy>Kaur, Sukhbir (NIH/NCI) [E]</cp:lastModifiedBy>
  <cp:revision>1</cp:revision>
  <dcterms:created xsi:type="dcterms:W3CDTF">2025-07-23T15:27:32Z</dcterms:created>
  <dcterms:modified xsi:type="dcterms:W3CDTF">2025-07-23T15:41:04Z</dcterms:modified>
</cp:coreProperties>
</file>